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9" r:id="rId2"/>
    <p:sldId id="257" r:id="rId3"/>
    <p:sldId id="260" r:id="rId4"/>
    <p:sldId id="264" r:id="rId5"/>
    <p:sldId id="268" r:id="rId6"/>
    <p:sldId id="272" r:id="rId7"/>
    <p:sldId id="276" r:id="rId8"/>
    <p:sldId id="280" r:id="rId9"/>
    <p:sldId id="284" r:id="rId10"/>
    <p:sldId id="288" r:id="rId11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A0185"/>
    <a:srgbClr val="15016B"/>
    <a:srgbClr val="1E0199"/>
    <a:srgbClr val="2401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1682" autoAdjust="0"/>
  </p:normalViewPr>
  <p:slideViewPr>
    <p:cSldViewPr showGuides="1">
      <p:cViewPr varScale="1">
        <p:scale>
          <a:sx n="93" d="100"/>
          <a:sy n="93" d="100"/>
        </p:scale>
        <p:origin x="-1138" y="-62"/>
      </p:cViewPr>
      <p:guideLst>
        <p:guide orient="horz" pos="4020"/>
        <p:guide pos="2880"/>
      </p:guideLst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47AD9-0755-465C-93C9-717C3A8A0530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F29880-4F34-4D75-B415-7FC0A977D9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84058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 altLang="ko-KR" baseline="0" dirty="0" smtClean="0"/>
          </a:p>
          <a:p>
            <a:pPr marL="228600" indent="-228600">
              <a:buAutoNum type="arabicPeriod"/>
            </a:pP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25665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2344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52816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8955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954619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593773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960111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929346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F29880-4F34-4D75-B415-7FC0A977D903}" type="slidenum">
              <a:rPr lang="ko-KR" altLang="en-US" smtClean="0"/>
              <a:t>10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005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4668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563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9501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6543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4839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6328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9584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4073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5789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2804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6347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D3CD9-0AE3-429D-ADC1-E2C5462810DB}" type="datetimeFigureOut">
              <a:rPr lang="ko-KR" altLang="en-US" smtClean="0"/>
              <a:t>2013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64DEC-6101-46BF-AAE6-13A64A1D4A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0802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35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7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5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9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3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7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3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71600" y="836712"/>
            <a:ext cx="7632848" cy="4862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200" b="1" cap="all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2200" b="1" cap="all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2200" b="1" cap="all" dirty="0" smtClean="0"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en-US" altLang="ko-KR" sz="2200" b="1" cap="all" dirty="0" smtClean="0">
                <a:latin typeface="Times New Roman" pitchFamily="18" charset="0"/>
                <a:cs typeface="Times New Roman" pitchFamily="18" charset="0"/>
              </a:rPr>
              <a:t>legend</a:t>
            </a:r>
            <a:endParaRPr lang="en-US" altLang="ko-KR" sz="2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2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22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22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ko-KR" sz="2200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altLang="ko-KR" sz="2200" b="1" dirty="0">
                <a:latin typeface="Times New Roman" pitchFamily="18" charset="0"/>
                <a:cs typeface="Times New Roman" pitchFamily="18" charset="0"/>
              </a:rPr>
              <a:t>. Interactive plots and AUC values for nine verified candidate </a:t>
            </a:r>
            <a:r>
              <a:rPr lang="en-US" altLang="ko-KR" sz="2200" b="1" dirty="0" smtClean="0">
                <a:latin typeface="Times New Roman" pitchFamily="18" charset="0"/>
                <a:cs typeface="Times New Roman" pitchFamily="18" charset="0"/>
              </a:rPr>
              <a:t>biomarkers</a:t>
            </a:r>
          </a:p>
          <a:p>
            <a:endParaRPr lang="en-US" altLang="ko-KR" sz="22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2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ko-KR" sz="2200" dirty="0">
                <a:latin typeface="Times New Roman" pitchFamily="18" charset="0"/>
                <a:cs typeface="Times New Roman" pitchFamily="18" charset="0"/>
              </a:rPr>
              <a:t>normalized peak areas of transitions were compared between the healthy control group and </a:t>
            </a:r>
            <a:r>
              <a:rPr lang="en-US" altLang="ko-KR" sz="2200" dirty="0" smtClean="0">
                <a:latin typeface="Times New Roman" pitchFamily="18" charset="0"/>
                <a:cs typeface="Times New Roman" pitchFamily="18" charset="0"/>
              </a:rPr>
              <a:t>before </a:t>
            </a:r>
            <a:r>
              <a:rPr lang="en-US" altLang="ko-KR" sz="2200" dirty="0">
                <a:latin typeface="Times New Roman" pitchFamily="18" charset="0"/>
                <a:cs typeface="Times New Roman" pitchFamily="18" charset="0"/>
              </a:rPr>
              <a:t>HCC </a:t>
            </a:r>
            <a:r>
              <a:rPr lang="en-US" altLang="ko-KR" sz="2200" dirty="0" smtClean="0">
                <a:latin typeface="Times New Roman" pitchFamily="18" charset="0"/>
                <a:cs typeface="Times New Roman" pitchFamily="18" charset="0"/>
              </a:rPr>
              <a:t>treatment group </a:t>
            </a:r>
            <a:r>
              <a:rPr lang="en-US" altLang="ko-KR" sz="2200" dirty="0">
                <a:latin typeface="Times New Roman" pitchFamily="18" charset="0"/>
                <a:cs typeface="Times New Roman" pitchFamily="18" charset="0"/>
              </a:rPr>
              <a:t>and between the </a:t>
            </a:r>
            <a:r>
              <a:rPr lang="en-US" altLang="ko-KR" sz="2200" dirty="0" smtClean="0">
                <a:latin typeface="Times New Roman" pitchFamily="18" charset="0"/>
                <a:cs typeface="Times New Roman" pitchFamily="18" charset="0"/>
              </a:rPr>
              <a:t>before </a:t>
            </a:r>
            <a:r>
              <a:rPr lang="en-US" altLang="ko-KR" sz="2200" dirty="0">
                <a:latin typeface="Times New Roman" pitchFamily="18" charset="0"/>
                <a:cs typeface="Times New Roman" pitchFamily="18" charset="0"/>
              </a:rPr>
              <a:t>HCC </a:t>
            </a:r>
            <a:r>
              <a:rPr lang="en-US" altLang="ko-KR" sz="2200" dirty="0" smtClean="0">
                <a:latin typeface="Times New Roman" pitchFamily="18" charset="0"/>
                <a:cs typeface="Times New Roman" pitchFamily="18" charset="0"/>
              </a:rPr>
              <a:t>treatment group </a:t>
            </a:r>
            <a:r>
              <a:rPr lang="en-US" altLang="ko-KR" sz="2200" dirty="0">
                <a:latin typeface="Times New Roman" pitchFamily="18" charset="0"/>
                <a:cs typeface="Times New Roman" pitchFamily="18" charset="0"/>
              </a:rPr>
              <a:t>and after HCC treatment group. The interactive plots and ROC curves are represented by the transition peak areas of the 9 proteins. Interactive plots of each target peptide were extrapolated versus the standard peptide with regard to relative concentration, sensitivity, and specificity. </a:t>
            </a:r>
            <a:endParaRPr lang="en-US" altLang="ko-KR" sz="2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2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2200" dirty="0">
                <a:latin typeface="Times New Roman" pitchFamily="18" charset="0"/>
                <a:cs typeface="Times New Roman" pitchFamily="18" charset="0"/>
              </a:rPr>
              <a:t>See also </a:t>
            </a:r>
            <a:r>
              <a:rPr lang="en-US" altLang="ko-KR" sz="2200" dirty="0" smtClean="0">
                <a:latin typeface="Times New Roman" pitchFamily="18" charset="0"/>
                <a:cs typeface="Times New Roman" pitchFamily="18" charset="0"/>
              </a:rPr>
              <a:t>Table 2.</a:t>
            </a:r>
            <a:endParaRPr lang="ko-KR" altLang="ko-KR" sz="2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14246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9115" y="676904"/>
            <a:ext cx="4562788" cy="2928486"/>
            <a:chOff x="9115" y="500514"/>
            <a:chExt cx="4562788" cy="2928486"/>
          </a:xfrm>
        </p:grpSpPr>
        <p:pic>
          <p:nvPicPr>
            <p:cNvPr id="34819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24"/>
            <a:stretch/>
          </p:blipFill>
          <p:spPr bwMode="auto">
            <a:xfrm>
              <a:off x="9115" y="500514"/>
              <a:ext cx="4562788" cy="29284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직사각형 9"/>
            <p:cNvSpPr/>
            <p:nvPr/>
          </p:nvSpPr>
          <p:spPr>
            <a:xfrm>
              <a:off x="2558237" y="2430513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949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0" y="3824526"/>
            <a:ext cx="4572896" cy="2930893"/>
            <a:chOff x="0" y="3927106"/>
            <a:chExt cx="4572896" cy="2930893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43"/>
            <a:stretch/>
          </p:blipFill>
          <p:spPr bwMode="auto">
            <a:xfrm>
              <a:off x="0" y="3927106"/>
              <a:ext cx="4572896" cy="29308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직사각형 10"/>
            <p:cNvSpPr/>
            <p:nvPr/>
          </p:nvSpPr>
          <p:spPr>
            <a:xfrm>
              <a:off x="2558237" y="5882264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608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4" name="직사각형 13"/>
          <p:cNvSpPr/>
          <p:nvPr/>
        </p:nvSpPr>
        <p:spPr>
          <a:xfrm>
            <a:off x="-4376" y="6782"/>
            <a:ext cx="915600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9.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Polyadenylate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-binding protein 1 (PABPC1) / EFSPFGTITSAK / 2+ / y9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92" b="13013"/>
          <a:stretch/>
        </p:blipFill>
        <p:spPr bwMode="auto">
          <a:xfrm>
            <a:off x="4575463" y="653634"/>
            <a:ext cx="4572097" cy="2568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77" b="5878"/>
          <a:stretch/>
        </p:blipFill>
        <p:spPr bwMode="auto">
          <a:xfrm>
            <a:off x="4572895" y="3807328"/>
            <a:ext cx="4577005" cy="28060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2976" y="3203832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9381" y="6346270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1235945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4175" y="887011"/>
            <a:ext cx="4567825" cy="2925355"/>
            <a:chOff x="4175" y="719669"/>
            <a:chExt cx="4567825" cy="2925355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10"/>
            <a:stretch/>
          </p:blipFill>
          <p:spPr bwMode="auto">
            <a:xfrm>
              <a:off x="4175" y="719669"/>
              <a:ext cx="4567825" cy="29253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직사각형 8"/>
            <p:cNvSpPr/>
            <p:nvPr/>
          </p:nvSpPr>
          <p:spPr>
            <a:xfrm>
              <a:off x="2558237" y="2668918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01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0" y="3910202"/>
            <a:ext cx="4572000" cy="2930893"/>
            <a:chOff x="0" y="3927106"/>
            <a:chExt cx="4572000" cy="2930893"/>
          </a:xfrm>
        </p:grpSpPr>
        <p:pic>
          <p:nvPicPr>
            <p:cNvPr id="5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27"/>
            <a:stretch/>
          </p:blipFill>
          <p:spPr bwMode="auto">
            <a:xfrm>
              <a:off x="0" y="3927106"/>
              <a:ext cx="4572000" cy="29308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직사각형 9"/>
            <p:cNvSpPr/>
            <p:nvPr/>
          </p:nvSpPr>
          <p:spPr>
            <a:xfrm>
              <a:off x="2567862" y="5882264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691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" name="직사각형 2"/>
          <p:cNvSpPr/>
          <p:nvPr/>
        </p:nvSpPr>
        <p:spPr>
          <a:xfrm>
            <a:off x="-1" y="288677"/>
            <a:ext cx="91329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. Very </a:t>
            </a:r>
            <a:r>
              <a:rPr lang="en-US" altLang="ko-KR" b="1" dirty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long-chain specific acyl-CoA dehydrogenase, mitochondria (ACADVL</a:t>
            </a:r>
            <a:r>
              <a:rPr lang="en-US" altLang="ko-KR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)  </a:t>
            </a:r>
          </a:p>
          <a:p>
            <a:r>
              <a:rPr lang="en-US" altLang="ko-KR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    ASNTAEVFFDGVR </a:t>
            </a:r>
            <a:r>
              <a:rPr lang="en-US" altLang="ko-KR" b="1" dirty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/ 2+ / y6</a:t>
            </a:r>
            <a:endParaRPr lang="ko-KR" altLang="en-US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30" b="13652"/>
          <a:stretch/>
        </p:blipFill>
        <p:spPr bwMode="auto">
          <a:xfrm>
            <a:off x="4571999" y="874432"/>
            <a:ext cx="4560988" cy="25353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00" b="11321"/>
          <a:stretch/>
        </p:blipFill>
        <p:spPr bwMode="auto">
          <a:xfrm>
            <a:off x="4572000" y="3885354"/>
            <a:ext cx="4572000" cy="262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2120" y="3391960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9381" y="6422786"/>
            <a:ext cx="2341563" cy="43508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sp>
        <p:nvSpPr>
          <p:cNvPr id="2" name="직사각형 1"/>
          <p:cNvSpPr/>
          <p:nvPr/>
        </p:nvSpPr>
        <p:spPr>
          <a:xfrm>
            <a:off x="19063" y="793"/>
            <a:ext cx="664116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kern="100" dirty="0">
                <a:latin typeface="Times New Roman"/>
              </a:rPr>
              <a:t>Supplementary </a:t>
            </a:r>
            <a:r>
              <a:rPr lang="en-US" altLang="ko-KR" sz="1400" kern="100" dirty="0" smtClean="0">
                <a:latin typeface="Times New Roman"/>
              </a:rPr>
              <a:t>Figure </a:t>
            </a:r>
            <a:r>
              <a:rPr lang="en-US" altLang="ko-KR" sz="1400" kern="100" dirty="0" smtClean="0">
                <a:latin typeface="Times New Roman"/>
              </a:rPr>
              <a:t>S2</a:t>
            </a:r>
            <a:r>
              <a:rPr lang="en-US" altLang="ko-KR" sz="1400" kern="100" dirty="0" smtClean="0">
                <a:latin typeface="Times New Roman"/>
              </a:rPr>
              <a:t>. The </a:t>
            </a:r>
            <a:r>
              <a:rPr lang="en-US" altLang="ko-KR" sz="1400" kern="100" dirty="0">
                <a:latin typeface="Times New Roman"/>
              </a:rPr>
              <a:t>ROCs and interactive plots of the 9 proteins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468027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/>
          <p:cNvGrpSpPr/>
          <p:nvPr/>
        </p:nvGrpSpPr>
        <p:grpSpPr>
          <a:xfrm>
            <a:off x="0" y="705948"/>
            <a:ext cx="4572000" cy="2938112"/>
            <a:chOff x="0" y="706912"/>
            <a:chExt cx="4572000" cy="2938112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16"/>
            <a:stretch/>
          </p:blipFill>
          <p:spPr bwMode="auto">
            <a:xfrm>
              <a:off x="0" y="706912"/>
              <a:ext cx="4572000" cy="29381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직사각형 7"/>
            <p:cNvSpPr/>
            <p:nvPr/>
          </p:nvSpPr>
          <p:spPr>
            <a:xfrm>
              <a:off x="2558237" y="2665787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920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0" y="3826199"/>
            <a:ext cx="4572000" cy="2930031"/>
            <a:chOff x="0" y="3936732"/>
            <a:chExt cx="4572000" cy="2930031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52"/>
            <a:stretch/>
          </p:blipFill>
          <p:spPr bwMode="auto">
            <a:xfrm>
              <a:off x="0" y="3936732"/>
              <a:ext cx="4572000" cy="29300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직사각형 8"/>
            <p:cNvSpPr/>
            <p:nvPr/>
          </p:nvSpPr>
          <p:spPr>
            <a:xfrm>
              <a:off x="2567862" y="5882264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44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" name="직사각형 1"/>
          <p:cNvSpPr/>
          <p:nvPr/>
        </p:nvSpPr>
        <p:spPr>
          <a:xfrm>
            <a:off x="-1906" y="10633"/>
            <a:ext cx="91407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2. Actin binding protein,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anillin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 (ANLN) / TQSLPVTEK / 2+ / y8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13" b="12956"/>
          <a:stretch/>
        </p:blipFill>
        <p:spPr bwMode="auto">
          <a:xfrm>
            <a:off x="4572000" y="691510"/>
            <a:ext cx="4572000" cy="25694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83" b="13074"/>
          <a:stretch/>
        </p:blipFill>
        <p:spPr bwMode="auto">
          <a:xfrm>
            <a:off x="4572640" y="3806184"/>
            <a:ext cx="4571360" cy="25625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3832" y="3240782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0237" y="6346270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114916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0" y="688844"/>
            <a:ext cx="4572000" cy="2938112"/>
            <a:chOff x="0" y="706912"/>
            <a:chExt cx="4572000" cy="2938112"/>
          </a:xfrm>
        </p:grpSpPr>
        <p:pic>
          <p:nvPicPr>
            <p:cNvPr id="10242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16"/>
            <a:stretch/>
          </p:blipFill>
          <p:spPr bwMode="auto">
            <a:xfrm>
              <a:off x="0" y="706912"/>
              <a:ext cx="4572000" cy="29381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직사각형 8"/>
            <p:cNvSpPr/>
            <p:nvPr/>
          </p:nvSpPr>
          <p:spPr>
            <a:xfrm>
              <a:off x="2567862" y="2665787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951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0" y="3821104"/>
            <a:ext cx="4572000" cy="2934586"/>
            <a:chOff x="0" y="3923414"/>
            <a:chExt cx="4572000" cy="2934586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19"/>
            <a:stretch/>
          </p:blipFill>
          <p:spPr bwMode="auto">
            <a:xfrm>
              <a:off x="0" y="3923414"/>
              <a:ext cx="4572000" cy="29345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직사각형 9"/>
            <p:cNvSpPr/>
            <p:nvPr/>
          </p:nvSpPr>
          <p:spPr>
            <a:xfrm>
              <a:off x="2567862" y="5882264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19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" name="직사각형 1"/>
          <p:cNvSpPr/>
          <p:nvPr/>
        </p:nvSpPr>
        <p:spPr>
          <a:xfrm>
            <a:off x="2008" y="10210"/>
            <a:ext cx="9144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3. Brain acid soluble protein 1 (BASP1) / AEGAATEEGTPK / 2+ / y6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70" b="8176"/>
          <a:stretch/>
        </p:blipFill>
        <p:spPr bwMode="auto">
          <a:xfrm>
            <a:off x="4572000" y="679921"/>
            <a:ext cx="4572000" cy="27347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38" b="12578"/>
          <a:stretch/>
        </p:blipFill>
        <p:spPr bwMode="auto">
          <a:xfrm>
            <a:off x="4574008" y="3798184"/>
            <a:ext cx="4572000" cy="2588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6400" y="3220976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093" y="6355414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396192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0" y="666289"/>
            <a:ext cx="4572000" cy="2934289"/>
            <a:chOff x="0" y="495299"/>
            <a:chExt cx="4572000" cy="2934289"/>
          </a:xfrm>
        </p:grpSpPr>
        <p:pic>
          <p:nvPicPr>
            <p:cNvPr id="1433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28"/>
            <a:stretch/>
          </p:blipFill>
          <p:spPr bwMode="auto">
            <a:xfrm>
              <a:off x="0" y="495299"/>
              <a:ext cx="4572000" cy="29342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직사각형 7"/>
            <p:cNvSpPr/>
            <p:nvPr/>
          </p:nvSpPr>
          <p:spPr>
            <a:xfrm>
              <a:off x="2567862" y="2449763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829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0" y="3812247"/>
            <a:ext cx="4572000" cy="2940639"/>
            <a:chOff x="0" y="3917950"/>
            <a:chExt cx="4572000" cy="2940639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243"/>
            <a:stretch/>
          </p:blipFill>
          <p:spPr bwMode="auto">
            <a:xfrm>
              <a:off x="0" y="3917950"/>
              <a:ext cx="4572000" cy="29406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직사각형 8"/>
            <p:cNvSpPr/>
            <p:nvPr/>
          </p:nvSpPr>
          <p:spPr>
            <a:xfrm>
              <a:off x="2567862" y="5882264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685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" name="직사각형 1"/>
          <p:cNvSpPr/>
          <p:nvPr/>
        </p:nvSpPr>
        <p:spPr>
          <a:xfrm>
            <a:off x="2506" y="9525"/>
            <a:ext cx="914149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4. C-1-tetrahydrofolate synthase, cytoplasmic (MTHFD1) / GVPTGFILPIR / 2+ / y5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05" b="13225"/>
          <a:stretch/>
        </p:blipFill>
        <p:spPr bwMode="auto">
          <a:xfrm>
            <a:off x="4569000" y="654091"/>
            <a:ext cx="4572000" cy="2557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23" b="12830"/>
          <a:stretch/>
        </p:blipFill>
        <p:spPr bwMode="auto">
          <a:xfrm>
            <a:off x="4568382" y="3797040"/>
            <a:ext cx="4572000" cy="25699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5832" y="3203832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9381" y="6337126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86320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0" y="673224"/>
            <a:ext cx="4563373" cy="2933700"/>
            <a:chOff x="-8626" y="495300"/>
            <a:chExt cx="4572000" cy="2933700"/>
          </a:xfrm>
        </p:grpSpPr>
        <p:pic>
          <p:nvPicPr>
            <p:cNvPr id="18434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45"/>
            <a:stretch/>
          </p:blipFill>
          <p:spPr bwMode="auto">
            <a:xfrm>
              <a:off x="-8626" y="495300"/>
              <a:ext cx="4572000" cy="29337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직사각형 9"/>
            <p:cNvSpPr/>
            <p:nvPr/>
          </p:nvSpPr>
          <p:spPr>
            <a:xfrm>
              <a:off x="2558237" y="2449763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946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1" y="3870945"/>
            <a:ext cx="4563374" cy="2860555"/>
            <a:chOff x="1" y="3990975"/>
            <a:chExt cx="4563374" cy="286055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420"/>
            <a:stretch/>
          </p:blipFill>
          <p:spPr bwMode="auto">
            <a:xfrm>
              <a:off x="1" y="3990975"/>
              <a:ext cx="4563374" cy="28605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직사각형 10"/>
            <p:cNvSpPr/>
            <p:nvPr/>
          </p:nvSpPr>
          <p:spPr>
            <a:xfrm>
              <a:off x="2519737" y="5800631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586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3" name="직사각형 12"/>
          <p:cNvSpPr/>
          <p:nvPr/>
        </p:nvSpPr>
        <p:spPr>
          <a:xfrm>
            <a:off x="0" y="7843"/>
            <a:ext cx="9144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5. Calpain-1 catalytic subunit (CAPN1) / YLGQDYEQLR / 2+ / y7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15" b="12898"/>
          <a:stretch/>
        </p:blipFill>
        <p:spPr bwMode="auto">
          <a:xfrm>
            <a:off x="4570691" y="706129"/>
            <a:ext cx="4573309" cy="24744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435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49"/>
          <a:stretch/>
        </p:blipFill>
        <p:spPr bwMode="auto">
          <a:xfrm>
            <a:off x="4572000" y="3851904"/>
            <a:ext cx="4583943" cy="2886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2976" y="3159256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8525" y="6327982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634765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/>
          <p:cNvGrpSpPr/>
          <p:nvPr/>
        </p:nvGrpSpPr>
        <p:grpSpPr>
          <a:xfrm>
            <a:off x="5267" y="686823"/>
            <a:ext cx="4558107" cy="2913755"/>
            <a:chOff x="5267" y="504824"/>
            <a:chExt cx="4558107" cy="2913755"/>
          </a:xfrm>
        </p:grpSpPr>
        <p:pic>
          <p:nvPicPr>
            <p:cNvPr id="2253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67"/>
            <a:stretch/>
          </p:blipFill>
          <p:spPr bwMode="auto">
            <a:xfrm>
              <a:off x="5267" y="504824"/>
              <a:ext cx="4558107" cy="29137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직사각형 7"/>
            <p:cNvSpPr/>
            <p:nvPr/>
          </p:nvSpPr>
          <p:spPr>
            <a:xfrm>
              <a:off x="2558237" y="2440138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867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3085" y="3817842"/>
            <a:ext cx="4569391" cy="2924174"/>
            <a:chOff x="3085" y="3933825"/>
            <a:chExt cx="4569391" cy="2924174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73"/>
            <a:stretch/>
          </p:blipFill>
          <p:spPr bwMode="auto">
            <a:xfrm>
              <a:off x="3085" y="3933825"/>
              <a:ext cx="4569391" cy="2924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직사각형 8"/>
            <p:cNvSpPr/>
            <p:nvPr/>
          </p:nvSpPr>
          <p:spPr>
            <a:xfrm>
              <a:off x="2567862" y="5872639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10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6" name="직사각형 15"/>
          <p:cNvSpPr/>
          <p:nvPr/>
        </p:nvSpPr>
        <p:spPr>
          <a:xfrm>
            <a:off x="6036" y="10210"/>
            <a:ext cx="91286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6. Complementary C4-A (C4A) / VGDTLNLNLR / 2+ / y5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60" b="13196"/>
          <a:stretch/>
        </p:blipFill>
        <p:spPr bwMode="auto">
          <a:xfrm>
            <a:off x="4575133" y="669304"/>
            <a:ext cx="4558106" cy="2548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24" b="13111"/>
          <a:stretch/>
        </p:blipFill>
        <p:spPr bwMode="auto">
          <a:xfrm>
            <a:off x="4568524" y="3798184"/>
            <a:ext cx="4561701" cy="2561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2120" y="3204976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0237" y="6346270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19941504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7537" y="689274"/>
            <a:ext cx="4564464" cy="2916117"/>
            <a:chOff x="7537" y="504824"/>
            <a:chExt cx="4564464" cy="2916117"/>
          </a:xfrm>
        </p:grpSpPr>
        <p:pic>
          <p:nvPicPr>
            <p:cNvPr id="26628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817"/>
            <a:stretch/>
          </p:blipFill>
          <p:spPr bwMode="auto">
            <a:xfrm>
              <a:off x="7537" y="504824"/>
              <a:ext cx="4564464" cy="29161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직사각형 9"/>
            <p:cNvSpPr/>
            <p:nvPr/>
          </p:nvSpPr>
          <p:spPr>
            <a:xfrm>
              <a:off x="2563229" y="2440138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56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7538" y="3810745"/>
            <a:ext cx="4564464" cy="2928048"/>
            <a:chOff x="7538" y="3924300"/>
            <a:chExt cx="4564464" cy="2928048"/>
          </a:xfrm>
        </p:grpSpPr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69"/>
            <a:stretch/>
          </p:blipFill>
          <p:spPr bwMode="auto">
            <a:xfrm>
              <a:off x="7538" y="3924300"/>
              <a:ext cx="4564464" cy="29280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직사각형 10"/>
            <p:cNvSpPr/>
            <p:nvPr/>
          </p:nvSpPr>
          <p:spPr>
            <a:xfrm>
              <a:off x="2567862" y="5872639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35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4" name="직사각형 13"/>
          <p:cNvSpPr/>
          <p:nvPr/>
        </p:nvSpPr>
        <p:spPr>
          <a:xfrm>
            <a:off x="7538" y="9525"/>
            <a:ext cx="91482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7. Alpha-fetoprotein (AFP) / GYQELLEK / 2+ / y6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22" b="13033"/>
          <a:stretch/>
        </p:blipFill>
        <p:spPr bwMode="auto">
          <a:xfrm>
            <a:off x="4572000" y="664215"/>
            <a:ext cx="4571999" cy="2562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51" b="12822"/>
          <a:stretch/>
        </p:blipFill>
        <p:spPr bwMode="auto">
          <a:xfrm>
            <a:off x="4573054" y="3787896"/>
            <a:ext cx="4582744" cy="2578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2120" y="3212976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9381" y="6337126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3185165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0" y="662065"/>
            <a:ext cx="4572000" cy="2933700"/>
            <a:chOff x="0" y="495300"/>
            <a:chExt cx="4572000" cy="2933700"/>
          </a:xfrm>
        </p:grpSpPr>
        <p:pic>
          <p:nvPicPr>
            <p:cNvPr id="30722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45"/>
            <a:stretch/>
          </p:blipFill>
          <p:spPr bwMode="auto">
            <a:xfrm>
              <a:off x="0" y="495300"/>
              <a:ext cx="4572000" cy="29337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직사각형 7"/>
            <p:cNvSpPr/>
            <p:nvPr/>
          </p:nvSpPr>
          <p:spPr>
            <a:xfrm>
              <a:off x="2567862" y="2449763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660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-3560" y="3806166"/>
            <a:ext cx="4575560" cy="2945895"/>
            <a:chOff x="-3560" y="3914774"/>
            <a:chExt cx="4575560" cy="294589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56"/>
            <a:stretch/>
          </p:blipFill>
          <p:spPr bwMode="auto">
            <a:xfrm>
              <a:off x="-3560" y="3914774"/>
              <a:ext cx="4575560" cy="29458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직사각형 8"/>
            <p:cNvSpPr/>
            <p:nvPr/>
          </p:nvSpPr>
          <p:spPr>
            <a:xfrm>
              <a:off x="2558237" y="5882264"/>
              <a:ext cx="11592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dirty="0" smtClean="0">
                  <a:latin typeface="Times New Roman" pitchFamily="18" charset="0"/>
                  <a:cs typeface="Times New Roman" pitchFamily="18" charset="0"/>
                </a:rPr>
                <a:t>AUC = 0.707</a:t>
              </a:r>
              <a:endParaRPr lang="ko-KR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4" name="직사각형 13"/>
          <p:cNvSpPr/>
          <p:nvPr/>
        </p:nvSpPr>
        <p:spPr>
          <a:xfrm>
            <a:off x="-3560" y="7292"/>
            <a:ext cx="914205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8. </a:t>
            </a:r>
            <a:r>
              <a:rPr lang="en-US" altLang="ko-KR" b="1" dirty="0" err="1">
                <a:latin typeface="Times New Roman" pitchFamily="18" charset="0"/>
                <a:cs typeface="Times New Roman" pitchFamily="18" charset="0"/>
              </a:rPr>
              <a:t>Filamin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-B (FLNB) / APLNVQFNSPLPGDAVK / 2+ / y13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22" b="12793"/>
          <a:stretch/>
        </p:blipFill>
        <p:spPr bwMode="auto">
          <a:xfrm>
            <a:off x="4572000" y="648032"/>
            <a:ext cx="4572000" cy="25712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00" b="13093"/>
          <a:stretch/>
        </p:blipFill>
        <p:spPr bwMode="auto">
          <a:xfrm>
            <a:off x="4569137" y="3787896"/>
            <a:ext cx="4572001" cy="2568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2976" y="3194688"/>
            <a:ext cx="2273300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0237" y="6346270"/>
            <a:ext cx="2341563" cy="4762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3334057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312</Words>
  <Application>Microsoft Office PowerPoint</Application>
  <PresentationFormat>화면 슬라이드 쇼(4:3)</PresentationFormat>
  <Paragraphs>45</Paragraphs>
  <Slides>10</Slides>
  <Notes>9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1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SK</dc:creator>
  <cp:lastModifiedBy>samsung</cp:lastModifiedBy>
  <cp:revision>93</cp:revision>
  <dcterms:created xsi:type="dcterms:W3CDTF">2012-11-22T02:18:45Z</dcterms:created>
  <dcterms:modified xsi:type="dcterms:W3CDTF">2013-04-10T03:48:16Z</dcterms:modified>
</cp:coreProperties>
</file>